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6" userDrawn="1">
          <p15:clr>
            <a:srgbClr val="A4A3A4"/>
          </p15:clr>
        </p15:guide>
        <p15:guide id="3" pos="720" userDrawn="1">
          <p15:clr>
            <a:srgbClr val="A4A3A4"/>
          </p15:clr>
        </p15:guide>
        <p15:guide id="4" pos="3600" userDrawn="1">
          <p15:clr>
            <a:srgbClr val="A4A3A4"/>
          </p15:clr>
        </p15:guide>
        <p15:guide id="5" pos="3504" userDrawn="1">
          <p15:clr>
            <a:srgbClr val="A4A3A4"/>
          </p15:clr>
        </p15:guide>
        <p15:guide id="6" pos="10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  <a:srgbClr val="B80000"/>
    <a:srgbClr val="990000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36" y="108"/>
      </p:cViewPr>
      <p:guideLst>
        <p:guide orient="horz" pos="2880"/>
        <p:guide pos="2136"/>
        <p:guide pos="720"/>
        <p:guide pos="3600"/>
        <p:guide pos="3504"/>
        <p:guide pos="10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vinash\Documents\Cumin%20metabolites%20data\Biochemical\CUMIN-Bioche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42658638258453"/>
          <c:y val="3.4909870500421686E-2"/>
          <c:w val="0.88016504554577735"/>
          <c:h val="0.831133495700424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ICP!$A$172</c:f>
              <c:strCache>
                <c:ptCount val="1"/>
                <c:pt idx="0">
                  <c:v>0 m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ICP!$B$177:$I$177</c:f>
                <c:numCache>
                  <c:formatCode>General</c:formatCode>
                  <c:ptCount val="8"/>
                  <c:pt idx="0">
                    <c:v>1.3157176182624615E-2</c:v>
                  </c:pt>
                  <c:pt idx="1">
                    <c:v>9.6124852490430731E-3</c:v>
                  </c:pt>
                  <c:pt idx="2">
                    <c:v>2.10478972479437E-2</c:v>
                  </c:pt>
                  <c:pt idx="3">
                    <c:v>7.7312962696911097E-2</c:v>
                  </c:pt>
                  <c:pt idx="4">
                    <c:v>4.6584635415812189E-3</c:v>
                  </c:pt>
                  <c:pt idx="5">
                    <c:v>8.0277011238112509E-4</c:v>
                  </c:pt>
                  <c:pt idx="6">
                    <c:v>3.7700445312315121E-3</c:v>
                  </c:pt>
                  <c:pt idx="7">
                    <c:v>7.9112157169588257E-4</c:v>
                  </c:pt>
                </c:numCache>
              </c:numRef>
            </c:plus>
            <c:minus>
              <c:numRef>
                <c:f>ICP!$B$177:$I$177</c:f>
                <c:numCache>
                  <c:formatCode>General</c:formatCode>
                  <c:ptCount val="8"/>
                  <c:pt idx="0">
                    <c:v>1.3157176182624615E-2</c:v>
                  </c:pt>
                  <c:pt idx="1">
                    <c:v>9.6124852490430731E-3</c:v>
                  </c:pt>
                  <c:pt idx="2">
                    <c:v>2.10478972479437E-2</c:v>
                  </c:pt>
                  <c:pt idx="3">
                    <c:v>7.7312962696911097E-2</c:v>
                  </c:pt>
                  <c:pt idx="4">
                    <c:v>4.6584635415812189E-3</c:v>
                  </c:pt>
                  <c:pt idx="5">
                    <c:v>8.0277011238112509E-4</c:v>
                  </c:pt>
                  <c:pt idx="6">
                    <c:v>3.7700445312315121E-3</c:v>
                  </c:pt>
                  <c:pt idx="7">
                    <c:v>7.911215716958825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ICP!$B$170:$I$171</c:f>
              <c:multiLvlStrCache>
                <c:ptCount val="8"/>
                <c:lvl>
                  <c:pt idx="0">
                    <c:v>Ca</c:v>
                  </c:pt>
                  <c:pt idx="1">
                    <c:v>Mg</c:v>
                  </c:pt>
                  <c:pt idx="2">
                    <c:v>K</c:v>
                  </c:pt>
                  <c:pt idx="3">
                    <c:v>Na</c:v>
                  </c:pt>
                  <c:pt idx="4">
                    <c:v>Ca</c:v>
                  </c:pt>
                  <c:pt idx="5">
                    <c:v>Mg</c:v>
                  </c:pt>
                  <c:pt idx="6">
                    <c:v>K</c:v>
                  </c:pt>
                  <c:pt idx="7">
                    <c:v>Na</c:v>
                  </c:pt>
                </c:lvl>
                <c:lvl>
                  <c:pt idx="0">
                    <c:v>Root</c:v>
                  </c:pt>
                  <c:pt idx="4">
                    <c:v>Shoot</c:v>
                  </c:pt>
                </c:lvl>
              </c:multiLvlStrCache>
            </c:multiLvlStrRef>
          </c:cat>
          <c:val>
            <c:numRef>
              <c:f>ICP!$B$172:$I$172</c:f>
              <c:numCache>
                <c:formatCode>General</c:formatCode>
                <c:ptCount val="8"/>
                <c:pt idx="0">
                  <c:v>0.1072852775</c:v>
                </c:pt>
                <c:pt idx="1">
                  <c:v>3.4658299626133551E-2</c:v>
                </c:pt>
                <c:pt idx="2">
                  <c:v>6.5963727465463529E-2</c:v>
                </c:pt>
                <c:pt idx="3">
                  <c:v>0.11491005825529245</c:v>
                </c:pt>
                <c:pt idx="4">
                  <c:v>1.3139028284408827E-2</c:v>
                </c:pt>
                <c:pt idx="5">
                  <c:v>3.4687178547078931E-3</c:v>
                </c:pt>
                <c:pt idx="6">
                  <c:v>2.9595702669784833E-2</c:v>
                </c:pt>
                <c:pt idx="7">
                  <c:v>7.938751907534335E-3</c:v>
                </c:pt>
              </c:numCache>
            </c:numRef>
          </c:val>
        </c:ser>
        <c:ser>
          <c:idx val="1"/>
          <c:order val="1"/>
          <c:tx>
            <c:strRef>
              <c:f>ICP!$A$173</c:f>
              <c:strCache>
                <c:ptCount val="1"/>
                <c:pt idx="0">
                  <c:v>50 m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ICP!$B$178:$I$178</c:f>
                <c:numCache>
                  <c:formatCode>General</c:formatCode>
                  <c:ptCount val="8"/>
                  <c:pt idx="0">
                    <c:v>2.6257744224774532E-2</c:v>
                  </c:pt>
                  <c:pt idx="1">
                    <c:v>7.0459331887384909E-3</c:v>
                  </c:pt>
                  <c:pt idx="2">
                    <c:v>2.7514503522872023E-2</c:v>
                  </c:pt>
                  <c:pt idx="3">
                    <c:v>8.3884307675790526E-2</c:v>
                  </c:pt>
                  <c:pt idx="4">
                    <c:v>3.6577778343073442E-3</c:v>
                  </c:pt>
                  <c:pt idx="5">
                    <c:v>4.0256415575916599E-4</c:v>
                  </c:pt>
                  <c:pt idx="6">
                    <c:v>1.7945058229755003E-2</c:v>
                  </c:pt>
                  <c:pt idx="7">
                    <c:v>6.0889854942361198E-3</c:v>
                  </c:pt>
                </c:numCache>
              </c:numRef>
            </c:plus>
            <c:minus>
              <c:numRef>
                <c:f>ICP!$B$178:$I$178</c:f>
                <c:numCache>
                  <c:formatCode>General</c:formatCode>
                  <c:ptCount val="8"/>
                  <c:pt idx="0">
                    <c:v>2.6257744224774532E-2</c:v>
                  </c:pt>
                  <c:pt idx="1">
                    <c:v>7.0459331887384909E-3</c:v>
                  </c:pt>
                  <c:pt idx="2">
                    <c:v>2.7514503522872023E-2</c:v>
                  </c:pt>
                  <c:pt idx="3">
                    <c:v>8.3884307675790526E-2</c:v>
                  </c:pt>
                  <c:pt idx="4">
                    <c:v>3.6577778343073442E-3</c:v>
                  </c:pt>
                  <c:pt idx="5">
                    <c:v>4.0256415575916599E-4</c:v>
                  </c:pt>
                  <c:pt idx="6">
                    <c:v>1.7945058229755003E-2</c:v>
                  </c:pt>
                  <c:pt idx="7">
                    <c:v>6.08898549423611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ICP!$B$170:$I$171</c:f>
              <c:multiLvlStrCache>
                <c:ptCount val="8"/>
                <c:lvl>
                  <c:pt idx="0">
                    <c:v>Ca</c:v>
                  </c:pt>
                  <c:pt idx="1">
                    <c:v>Mg</c:v>
                  </c:pt>
                  <c:pt idx="2">
                    <c:v>K</c:v>
                  </c:pt>
                  <c:pt idx="3">
                    <c:v>Na</c:v>
                  </c:pt>
                  <c:pt idx="4">
                    <c:v>Ca</c:v>
                  </c:pt>
                  <c:pt idx="5">
                    <c:v>Mg</c:v>
                  </c:pt>
                  <c:pt idx="6">
                    <c:v>K</c:v>
                  </c:pt>
                  <c:pt idx="7">
                    <c:v>Na</c:v>
                  </c:pt>
                </c:lvl>
                <c:lvl>
                  <c:pt idx="0">
                    <c:v>Root</c:v>
                  </c:pt>
                  <c:pt idx="4">
                    <c:v>Shoot</c:v>
                  </c:pt>
                </c:lvl>
              </c:multiLvlStrCache>
            </c:multiLvlStrRef>
          </c:cat>
          <c:val>
            <c:numRef>
              <c:f>ICP!$B$173:$I$173</c:f>
              <c:numCache>
                <c:formatCode>General</c:formatCode>
                <c:ptCount val="8"/>
                <c:pt idx="0">
                  <c:v>9.0381136000000001E-2</c:v>
                </c:pt>
                <c:pt idx="1">
                  <c:v>2.313266105260383E-2</c:v>
                </c:pt>
                <c:pt idx="2">
                  <c:v>6.1355107957490274E-2</c:v>
                </c:pt>
                <c:pt idx="3">
                  <c:v>0.1051677715308023</c:v>
                </c:pt>
                <c:pt idx="4">
                  <c:v>1.0154063403532721E-2</c:v>
                </c:pt>
                <c:pt idx="5">
                  <c:v>3.0318740896846646E-3</c:v>
                </c:pt>
                <c:pt idx="6">
                  <c:v>3.3184109412946201E-2</c:v>
                </c:pt>
                <c:pt idx="7">
                  <c:v>2.8394361376384531E-2</c:v>
                </c:pt>
              </c:numCache>
            </c:numRef>
          </c:val>
        </c:ser>
        <c:ser>
          <c:idx val="2"/>
          <c:order val="2"/>
          <c:tx>
            <c:strRef>
              <c:f>ICP!$A$174</c:f>
              <c:strCache>
                <c:ptCount val="1"/>
                <c:pt idx="0">
                  <c:v>100 mM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ICP!$B$179:$I$179</c:f>
                <c:numCache>
                  <c:formatCode>General</c:formatCode>
                  <c:ptCount val="8"/>
                  <c:pt idx="0">
                    <c:v>3.661388872067646E-2</c:v>
                  </c:pt>
                  <c:pt idx="1">
                    <c:v>4.1716639224495707E-3</c:v>
                  </c:pt>
                  <c:pt idx="2">
                    <c:v>2.1687370325822325E-2</c:v>
                  </c:pt>
                  <c:pt idx="3">
                    <c:v>5.6964868335014672E-3</c:v>
                  </c:pt>
                  <c:pt idx="4">
                    <c:v>2.8011997059422711E-3</c:v>
                  </c:pt>
                  <c:pt idx="5">
                    <c:v>5.681375520427045E-5</c:v>
                  </c:pt>
                  <c:pt idx="6">
                    <c:v>2.1235208700766659E-3</c:v>
                  </c:pt>
                  <c:pt idx="7">
                    <c:v>1.0299589477760924E-2</c:v>
                  </c:pt>
                </c:numCache>
              </c:numRef>
            </c:plus>
            <c:minus>
              <c:numRef>
                <c:f>ICP!$B$179:$I$179</c:f>
                <c:numCache>
                  <c:formatCode>General</c:formatCode>
                  <c:ptCount val="8"/>
                  <c:pt idx="0">
                    <c:v>3.661388872067646E-2</c:v>
                  </c:pt>
                  <c:pt idx="1">
                    <c:v>4.1716639224495707E-3</c:v>
                  </c:pt>
                  <c:pt idx="2">
                    <c:v>2.1687370325822325E-2</c:v>
                  </c:pt>
                  <c:pt idx="3">
                    <c:v>5.6964868335014672E-3</c:v>
                  </c:pt>
                  <c:pt idx="4">
                    <c:v>2.8011997059422711E-3</c:v>
                  </c:pt>
                  <c:pt idx="5">
                    <c:v>5.681375520427045E-5</c:v>
                  </c:pt>
                  <c:pt idx="6">
                    <c:v>2.1235208700766659E-3</c:v>
                  </c:pt>
                  <c:pt idx="7">
                    <c:v>1.02995894777609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ICP!$B$170:$I$171</c:f>
              <c:multiLvlStrCache>
                <c:ptCount val="8"/>
                <c:lvl>
                  <c:pt idx="0">
                    <c:v>Ca</c:v>
                  </c:pt>
                  <c:pt idx="1">
                    <c:v>Mg</c:v>
                  </c:pt>
                  <c:pt idx="2">
                    <c:v>K</c:v>
                  </c:pt>
                  <c:pt idx="3">
                    <c:v>Na</c:v>
                  </c:pt>
                  <c:pt idx="4">
                    <c:v>Ca</c:v>
                  </c:pt>
                  <c:pt idx="5">
                    <c:v>Mg</c:v>
                  </c:pt>
                  <c:pt idx="6">
                    <c:v>K</c:v>
                  </c:pt>
                  <c:pt idx="7">
                    <c:v>Na</c:v>
                  </c:pt>
                </c:lvl>
                <c:lvl>
                  <c:pt idx="0">
                    <c:v>Root</c:v>
                  </c:pt>
                  <c:pt idx="4">
                    <c:v>Shoot</c:v>
                  </c:pt>
                </c:lvl>
              </c:multiLvlStrCache>
            </c:multiLvlStrRef>
          </c:cat>
          <c:val>
            <c:numRef>
              <c:f>ICP!$B$174:$I$174</c:f>
              <c:numCache>
                <c:formatCode>General</c:formatCode>
                <c:ptCount val="8"/>
                <c:pt idx="0">
                  <c:v>7.9854957000000004E-2</c:v>
                </c:pt>
                <c:pt idx="1">
                  <c:v>2.1858462263514407E-2</c:v>
                </c:pt>
                <c:pt idx="2">
                  <c:v>7.2149957809065912E-2</c:v>
                </c:pt>
                <c:pt idx="3">
                  <c:v>8.584938167885689E-2</c:v>
                </c:pt>
                <c:pt idx="4">
                  <c:v>7.2436091298701995E-3</c:v>
                </c:pt>
                <c:pt idx="5">
                  <c:v>2.4022301330468556E-3</c:v>
                </c:pt>
                <c:pt idx="6">
                  <c:v>2.2169792515536121E-2</c:v>
                </c:pt>
                <c:pt idx="7">
                  <c:v>4.457854662810170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7081296"/>
        <c:axId val="1207080208"/>
      </c:barChart>
      <c:catAx>
        <c:axId val="1207081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07080208"/>
        <c:crosses val="autoZero"/>
        <c:auto val="1"/>
        <c:lblAlgn val="ctr"/>
        <c:lblOffset val="100"/>
        <c:noMultiLvlLbl val="0"/>
      </c:catAx>
      <c:valAx>
        <c:axId val="120708020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ount</a:t>
                </a:r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mg per mg </a:t>
                </a:r>
                <a:r>
                  <a:rPr lang="en-US" sz="12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w</a:t>
                </a:r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</a:p>
            </c:rich>
          </c:tx>
          <c:layout>
            <c:manualLayout>
              <c:xMode val="edge"/>
              <c:yMode val="edge"/>
              <c:x val="2.7777777777777809E-3"/>
              <c:y val="0.207502916302128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07081296"/>
        <c:crosses val="autoZero"/>
        <c:crossBetween val="between"/>
        <c:majorUnit val="5.0000000000000024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351373799794011"/>
          <c:y val="4.0162997643312603E-2"/>
          <c:w val="0.30260627406445606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rgbClr val="0000CC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808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1067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3727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4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7922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4091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3621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065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186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16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7947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1001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0668599"/>
              </p:ext>
            </p:extLst>
          </p:nvPr>
        </p:nvGraphicFramePr>
        <p:xfrm>
          <a:off x="228600" y="696466"/>
          <a:ext cx="6477000" cy="35580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184150" y="4312588"/>
            <a:ext cx="64897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tabLst>
                <a:tab pos="457200" algn="l"/>
              </a:tabLst>
            </a:pPr>
            <a:r>
              <a:rPr lang="en-GB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5 Fig.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Determination of some ions contents in cumin under salinity stress.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Value represents the mean ± SE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473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</TotalTime>
  <Words>2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ang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inash Mishra</dc:creator>
  <cp:lastModifiedBy>Avinash Mishra</cp:lastModifiedBy>
  <cp:revision>33</cp:revision>
  <dcterms:created xsi:type="dcterms:W3CDTF">2015-01-03T04:36:46Z</dcterms:created>
  <dcterms:modified xsi:type="dcterms:W3CDTF">2015-11-21T07:02:30Z</dcterms:modified>
</cp:coreProperties>
</file>